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91" r:id="rId2"/>
  </p:sldIdLst>
  <p:sldSz cx="6840538" cy="6840538"/>
  <p:notesSz cx="6858000" cy="9144000"/>
  <p:defaultTextStyle>
    <a:defPPr>
      <a:defRPr lang="en-US"/>
    </a:defPPr>
    <a:lvl1pPr marL="0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1pPr>
    <a:lvl2pPr marL="328315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2pPr>
    <a:lvl3pPr marL="656631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3pPr>
    <a:lvl4pPr marL="984946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4pPr>
    <a:lvl5pPr marL="1313261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5pPr>
    <a:lvl6pPr marL="1641577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6pPr>
    <a:lvl7pPr marL="1969892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7pPr>
    <a:lvl8pPr marL="2298207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8pPr>
    <a:lvl9pPr marL="2626523" algn="l" defTabSz="656631" rtl="0" eaLnBrk="1" latinLnBrk="0" hangingPunct="1">
      <a:defRPr sz="129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690"/>
    <p:restoredTop sz="94676"/>
  </p:normalViewPr>
  <p:slideViewPr>
    <p:cSldViewPr snapToGrid="0" snapToObjects="1">
      <p:cViewPr varScale="1">
        <p:scale>
          <a:sx n="128" d="100"/>
          <a:sy n="128" d="100"/>
        </p:scale>
        <p:origin x="23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119505"/>
            <a:ext cx="5814457" cy="2381521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3592866"/>
            <a:ext cx="5130404" cy="1651546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872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364195"/>
            <a:ext cx="1474991" cy="579704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364195"/>
            <a:ext cx="4339466" cy="579704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550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342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1705386"/>
            <a:ext cx="5899964" cy="2845473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4577779"/>
            <a:ext cx="5899964" cy="149636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25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1820976"/>
            <a:ext cx="2907229" cy="43402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1820976"/>
            <a:ext cx="2907229" cy="43402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118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364197"/>
            <a:ext cx="5899964" cy="13221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1676882"/>
            <a:ext cx="2893868" cy="821814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2498697"/>
            <a:ext cx="2893868" cy="36752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1676882"/>
            <a:ext cx="2908120" cy="821814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2498697"/>
            <a:ext cx="2908120" cy="36752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617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475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803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56036"/>
            <a:ext cx="2206252" cy="1596126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984912"/>
            <a:ext cx="3463022" cy="4861216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052161"/>
            <a:ext cx="2206252" cy="3801883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954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56036"/>
            <a:ext cx="2206252" cy="1596126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984912"/>
            <a:ext cx="3463022" cy="4861216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052161"/>
            <a:ext cx="2206252" cy="3801883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397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364197"/>
            <a:ext cx="5899964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1820976"/>
            <a:ext cx="5899964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6340167"/>
            <a:ext cx="1539121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946279-6A3A-0B49-9BB0-526B6FF0991D}" type="datetimeFigureOut">
              <a:rPr lang="en-US" smtClean="0"/>
              <a:t>10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6340167"/>
            <a:ext cx="230868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6340167"/>
            <a:ext cx="1539121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4B49F-17EC-854B-A7F5-0BECC9E842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987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47783" y="232940"/>
            <a:ext cx="2027166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All PCI procedures in Morriston Cardiac Centre (Swansea)</a:t>
            </a:r>
          </a:p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2018-2022 (n=8,055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271D859-5053-D641-A8E9-6EC381890F83}"/>
              </a:ext>
            </a:extLst>
          </p:cNvPr>
          <p:cNvSpPr txBox="1"/>
          <p:nvPr/>
        </p:nvSpPr>
        <p:spPr>
          <a:xfrm>
            <a:off x="707911" y="4279258"/>
            <a:ext cx="542471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CHIP-PCI study population (n=2,295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C58C578-01F1-FB40-ADE3-3F90AB61C140}"/>
              </a:ext>
            </a:extLst>
          </p:cNvPr>
          <p:cNvSpPr/>
          <p:nvPr/>
        </p:nvSpPr>
        <p:spPr>
          <a:xfrm>
            <a:off x="513806" y="6074518"/>
            <a:ext cx="560926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entury Gothic" charset="0"/>
                <a:ea typeface="Century Gothic" charset="0"/>
                <a:cs typeface="Century Gothic" charset="0"/>
              </a:rPr>
              <a:t>Supplementary Figure S1: </a:t>
            </a:r>
            <a:r>
              <a:rPr lang="en-GB" sz="1200" dirty="0">
                <a:latin typeface="Century Gothic" charset="0"/>
                <a:ea typeface="Century Gothic" charset="0"/>
                <a:cs typeface="Century Gothic" charset="0"/>
              </a:rPr>
              <a:t>Consort flow diagram for study population</a:t>
            </a:r>
            <a:endParaRPr lang="en-US" sz="1200" dirty="0">
              <a:latin typeface="Century Gothic" panose="020B0502020202020204" pitchFamily="34" charset="0"/>
              <a:ea typeface="Century Gothic" charset="0"/>
              <a:cs typeface="Century Gothic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8DDA330-E411-C2CC-EAAA-10890B7FBD03}"/>
              </a:ext>
            </a:extLst>
          </p:cNvPr>
          <p:cNvSpPr txBox="1"/>
          <p:nvPr/>
        </p:nvSpPr>
        <p:spPr>
          <a:xfrm>
            <a:off x="2406686" y="239154"/>
            <a:ext cx="2027166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All PCI procedures in University Hospital of Wales (Cardiff)</a:t>
            </a:r>
          </a:p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2018-2022 (n=8,388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F4AB94-142D-8A2D-CE3D-0E75CC6FDA15}"/>
              </a:ext>
            </a:extLst>
          </p:cNvPr>
          <p:cNvSpPr txBox="1"/>
          <p:nvPr/>
        </p:nvSpPr>
        <p:spPr>
          <a:xfrm>
            <a:off x="4665589" y="232179"/>
            <a:ext cx="2027166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All PCI procedures in Grange University Hospital (Cwmbran)</a:t>
            </a:r>
          </a:p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2018-2022 (n=3,509)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990011A8-E097-7399-1799-33DB4A68F3CE}"/>
              </a:ext>
            </a:extLst>
          </p:cNvPr>
          <p:cNvCxnSpPr>
            <a:cxnSpLocks/>
          </p:cNvCxnSpPr>
          <p:nvPr/>
        </p:nvCxnSpPr>
        <p:spPr>
          <a:xfrm>
            <a:off x="1161366" y="1070150"/>
            <a:ext cx="0" cy="126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73901AC-7928-DFD4-C84C-65E7B4ADE047}"/>
              </a:ext>
            </a:extLst>
          </p:cNvPr>
          <p:cNvCxnSpPr>
            <a:cxnSpLocks/>
          </p:cNvCxnSpPr>
          <p:nvPr/>
        </p:nvCxnSpPr>
        <p:spPr>
          <a:xfrm>
            <a:off x="3422771" y="1070151"/>
            <a:ext cx="0" cy="126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0B59DB6-6541-40BE-7A76-C921CE977DB2}"/>
              </a:ext>
            </a:extLst>
          </p:cNvPr>
          <p:cNvCxnSpPr>
            <a:cxnSpLocks/>
          </p:cNvCxnSpPr>
          <p:nvPr/>
        </p:nvCxnSpPr>
        <p:spPr>
          <a:xfrm>
            <a:off x="5676669" y="1063175"/>
            <a:ext cx="0" cy="126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601E5F5-2858-65F8-66C1-D2C982BB5006}"/>
              </a:ext>
            </a:extLst>
          </p:cNvPr>
          <p:cNvSpPr txBox="1"/>
          <p:nvPr/>
        </p:nvSpPr>
        <p:spPr>
          <a:xfrm>
            <a:off x="147783" y="2344317"/>
            <a:ext cx="2069559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Excluded CHIP-PCI Score &lt;3 and emergency indications (STEMI/Shock)</a:t>
            </a:r>
          </a:p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(n=836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5E78E9-6477-4697-5BC0-0DA3D6105600}"/>
              </a:ext>
            </a:extLst>
          </p:cNvPr>
          <p:cNvSpPr txBox="1"/>
          <p:nvPr/>
        </p:nvSpPr>
        <p:spPr>
          <a:xfrm>
            <a:off x="2406686" y="2344317"/>
            <a:ext cx="2069559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Excluded CHIP-PCI Score &lt;3 and emergency indications (STEMI/Shock)</a:t>
            </a:r>
          </a:p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(n=1,064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D8584AF-2731-2CBC-C3C9-55CC0FF29260}"/>
              </a:ext>
            </a:extLst>
          </p:cNvPr>
          <p:cNvSpPr txBox="1"/>
          <p:nvPr/>
        </p:nvSpPr>
        <p:spPr>
          <a:xfrm>
            <a:off x="4665589" y="2344317"/>
            <a:ext cx="2069559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Excluded CHIP-PCI Score &lt;3 and emergency indications (STEMI/Shock)</a:t>
            </a:r>
          </a:p>
          <a:p>
            <a:pPr algn="ctr"/>
            <a:r>
              <a:rPr lang="en-US" sz="1200" dirty="0">
                <a:latin typeface="Century Gothic" panose="020B0502020202020204" pitchFamily="34" charset="0"/>
                <a:ea typeface="Century Gothic" charset="0"/>
                <a:cs typeface="Century Gothic" charset="0"/>
              </a:rPr>
              <a:t>(n=395)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64D9F2FB-3F2C-2D62-E1BD-96C8730880C4}"/>
              </a:ext>
            </a:extLst>
          </p:cNvPr>
          <p:cNvCxnSpPr>
            <a:cxnSpLocks/>
          </p:cNvCxnSpPr>
          <p:nvPr/>
        </p:nvCxnSpPr>
        <p:spPr>
          <a:xfrm>
            <a:off x="1158864" y="3185253"/>
            <a:ext cx="0" cy="108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528A755-05F9-5060-3C72-D03E44D419E4}"/>
              </a:ext>
            </a:extLst>
          </p:cNvPr>
          <p:cNvCxnSpPr>
            <a:cxnSpLocks/>
          </p:cNvCxnSpPr>
          <p:nvPr/>
        </p:nvCxnSpPr>
        <p:spPr>
          <a:xfrm>
            <a:off x="3420269" y="3185254"/>
            <a:ext cx="0" cy="108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25C5D76-9164-E41D-36AC-1B9BBA59798C}"/>
              </a:ext>
            </a:extLst>
          </p:cNvPr>
          <p:cNvCxnSpPr>
            <a:cxnSpLocks/>
          </p:cNvCxnSpPr>
          <p:nvPr/>
        </p:nvCxnSpPr>
        <p:spPr>
          <a:xfrm>
            <a:off x="5674167" y="3178278"/>
            <a:ext cx="0" cy="108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098046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</TotalTime>
  <Words>121</Words>
  <Application>Microsoft Macintosh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entury Gothic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 Kinnaird</dc:creator>
  <cp:lastModifiedBy>Majd Protty</cp:lastModifiedBy>
  <cp:revision>16</cp:revision>
  <dcterms:created xsi:type="dcterms:W3CDTF">2019-02-10T00:56:35Z</dcterms:created>
  <dcterms:modified xsi:type="dcterms:W3CDTF">2024-10-04T08:40:53Z</dcterms:modified>
</cp:coreProperties>
</file>